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1" r:id="rId3"/>
    <p:sldId id="264" r:id="rId4"/>
  </p:sldIdLst>
  <p:sldSz cx="9144000" cy="6858000" type="screen4x3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5" d="100"/>
          <a:sy n="115" d="100"/>
        </p:scale>
        <p:origin x="-1488" y="72"/>
      </p:cViewPr>
      <p:guideLst>
        <p:guide orient="horz" pos="211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9746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5858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4399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2031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7329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418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9378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0737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7853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9100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9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F687E-DA86-4318-AD72-A08ED97F8AFD}" type="datetimeFigureOut">
              <a:rPr lang="ko-KR" altLang="en-US" smtClean="0"/>
              <a:t>2021-01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2DA8B6-0C46-4990-B170-F32BFAF913F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002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JK\OneDrive - 고려대학교\MyDocument\바탕 화면\그림3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360" y="343867"/>
            <a:ext cx="8078241" cy="43092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5496" y="548680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CO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5496" y="2708920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WPC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99592" y="308177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43808" y="298315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860032" y="313916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1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804248" y="321616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2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99592" y="2466262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843808" y="2456400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860032" y="2472001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1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804248" y="2479701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2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51520" y="5281463"/>
            <a:ext cx="864096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ve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icture of B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nd T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ell populations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y FACS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.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ts were fed experimental diets (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; amino acids supplemented diet or WPC; 1% whey protein concentrate supplemented diet) for 14 days and then antigen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magglutinin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ptide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were injected two times (Day 0 and Day 14). Collected blood after antigen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jections were incubated with antibodies against CD45R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)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CD3 (T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),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pulations were determined with </a:t>
            </a:r>
            <a:r>
              <a:rPr lang="en-US" altLang="ko-KR" sz="14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CSCalibur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low cytometer (BD Biosciences).</a:t>
            </a:r>
            <a:endParaRPr lang="ko-KR" altLang="en-US" sz="14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4378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JK\OneDrive - 고려대학교\MyDocument\바탕 화면\Tc\그림4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569" y="404664"/>
            <a:ext cx="8424862" cy="4705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0" y="692696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CO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-56511" y="2799285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WPC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56934" y="367139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780678" y="350161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877788" y="360595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1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957142" y="357128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2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27345" y="2712378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751089" y="2695400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48199" y="2705834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1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927553" y="2702367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2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1520" y="5281463"/>
            <a:ext cx="864096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ive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icture of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totoxic T</a:t>
            </a:r>
            <a:r>
              <a:rPr lang="en-US" altLang="ko-KR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ell population by FACS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nalysis.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ts were fed experimental diets (CON; amino acids supplemented diet or WPC; 1% whey protein concentrate supplemented diet) for 14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s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then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tigen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hemagglutinin peptide) were injected two times (Day 0 and Day 14). Collected blood after antigen injections were incubated with antibodies against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 (T cell)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 (cytotoxic T cell),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pulations were determined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14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CSCalibur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low cytometer (BD Biosciences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61861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C:\Users\JK\OneDrive - 고려대학교\MyDocument\바탕 화면\Th cell\Th cell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631" y="350412"/>
            <a:ext cx="8186737" cy="45164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0" y="692696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CO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-56511" y="2799285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WPC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66422" y="262803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798434" y="261381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860032" y="254059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1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902890" y="268348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2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59018" y="2605904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791030" y="2604482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7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852628" y="2597160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14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895486" y="2611449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anose="020B0604020202020204" pitchFamily="34" charset="0"/>
                <a:ea typeface="Amiri" panose="00000500000000000000" pitchFamily="2" charset="-78"/>
                <a:cs typeface="Arial" panose="020B0604020202020204" pitchFamily="34" charset="0"/>
              </a:rPr>
              <a:t>Day 21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51520" y="5281463"/>
            <a:ext cx="871296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ve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icture of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per T cell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opulation by FACS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analysis.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ts were fed experimental diets (CON; amino acids supplemented diet or WPC; 1% whey protein concentrate supplemented diet) for 14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s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n antigen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hemagglutinin peptide) were injected two times (Day 0 and Day 14). Collected blood after antigen injections were incubated with antibodies against CD3 (T cell) and </a:t>
            </a:r>
            <a:r>
              <a:rPr lang="en-US" altLang="ko-KR" sz="14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 (helper T 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), and populations were determined with </a:t>
            </a:r>
            <a:r>
              <a:rPr lang="en-US" altLang="ko-KR" sz="14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CSCalibur</a:t>
            </a:r>
            <a:r>
              <a:rPr lang="en-US" altLang="ko-KR" sz="14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low cytometer (BD Biosciences).</a:t>
            </a:r>
            <a:endParaRPr lang="ko-KR" altLang="en-US" sz="14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869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</TotalTime>
  <Words>334</Words>
  <Application>Microsoft Office PowerPoint</Application>
  <PresentationFormat>화면 슬라이드 쇼(4:3)</PresentationFormat>
  <Paragraphs>33</Paragraphs>
  <Slides>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K</dc:creator>
  <cp:lastModifiedBy>JK</cp:lastModifiedBy>
  <cp:revision>19</cp:revision>
  <cp:lastPrinted>2021-01-08T02:02:35Z</cp:lastPrinted>
  <dcterms:created xsi:type="dcterms:W3CDTF">2021-01-08T02:02:10Z</dcterms:created>
  <dcterms:modified xsi:type="dcterms:W3CDTF">2021-01-13T07:33:01Z</dcterms:modified>
</cp:coreProperties>
</file>